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E5FDD-6552-49C2-9D94-0DD2BC75EE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09AD8C-A54C-4E7E-84D5-FAB2A5F723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0BBFF-3BFE-4F5F-8980-AEFB18C828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A266D7-B731-4187-8704-2A1B1C1603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5BB886-A010-4200-A65C-6D04E6B9CB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3F4FE3-DCA1-407F-8016-A6A9391D1F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CBF538-8F5C-4828-8D1F-380C6C3736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C9EE04-63A1-4B39-94FB-AA81057249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515DC-7DA8-4F06-AAA9-1F234DF7CB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825FE0-5F93-4280-AA06-D7068B8DF9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52974-39E4-4506-B661-5BAAF24503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4AE253-8E2F-4E39-A73F-91A0D010A7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C3FA20-E8E2-4A31-9D92-4F0024A3919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052720" y="1417680"/>
            <a:ext cx="0" cy="35528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052720" y="4970520"/>
            <a:ext cx="47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052720" y="4465800"/>
            <a:ext cx="47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052720" y="3951360"/>
            <a:ext cx="47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052720" y="3446640"/>
            <a:ext cx="47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052720" y="2941560"/>
            <a:ext cx="47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052720" y="2436840"/>
            <a:ext cx="47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052720" y="1922400"/>
            <a:ext cx="47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052720" y="1417680"/>
            <a:ext cx="47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052720" y="4970520"/>
            <a:ext cx="5257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V="1">
            <a:off x="2052720" y="4923000"/>
            <a:ext cx="0" cy="47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V="1">
            <a:off x="2147760" y="4923000"/>
            <a:ext cx="0" cy="47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V="1">
            <a:off x="2776680" y="4923000"/>
            <a:ext cx="0" cy="47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V="1">
            <a:off x="3414600" y="4923000"/>
            <a:ext cx="0" cy="47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V="1">
            <a:off x="4043520" y="4923000"/>
            <a:ext cx="0" cy="47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V="1">
            <a:off x="4681440" y="4923000"/>
            <a:ext cx="0" cy="47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5319720" y="4923000"/>
            <a:ext cx="0" cy="47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5948280" y="4923000"/>
            <a:ext cx="0" cy="47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6586560" y="4923000"/>
            <a:ext cx="0" cy="47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7215120" y="4923000"/>
            <a:ext cx="0" cy="47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147760" y="2084400"/>
            <a:ext cx="5067360" cy="2752560"/>
          </a:xfrm>
          <a:custGeom>
            <a:avLst/>
            <a:gdLst/>
            <a:ahLst/>
            <a:rect l="l" t="t" r="r" b="b"/>
            <a:pathLst>
              <a:path w="532" h="289">
                <a:moveTo>
                  <a:pt x="0" y="289"/>
                </a:moveTo>
                <a:lnTo>
                  <a:pt x="66" y="239"/>
                </a:lnTo>
                <a:lnTo>
                  <a:pt x="133" y="191"/>
                </a:lnTo>
                <a:lnTo>
                  <a:pt x="199" y="143"/>
                </a:lnTo>
                <a:lnTo>
                  <a:pt x="266" y="105"/>
                </a:lnTo>
                <a:lnTo>
                  <a:pt x="333" y="71"/>
                </a:lnTo>
                <a:lnTo>
                  <a:pt x="399" y="46"/>
                </a:lnTo>
                <a:lnTo>
                  <a:pt x="466" y="23"/>
                </a:lnTo>
                <a:lnTo>
                  <a:pt x="532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2147760" y="4789440"/>
            <a:ext cx="0" cy="47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119320" y="478944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V="1">
            <a:off x="2776680" y="4294080"/>
            <a:ext cx="0" cy="66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747880" y="429408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V="1">
            <a:off x="3414600" y="3808080"/>
            <a:ext cx="0" cy="95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386160" y="380844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V="1">
            <a:off x="4043520" y="3322800"/>
            <a:ext cx="0" cy="123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014720" y="332280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V="1">
            <a:off x="4681440" y="294120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653000" y="294156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flipV="1">
            <a:off x="5319720" y="2579400"/>
            <a:ext cx="0" cy="181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5291280" y="257976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flipV="1">
            <a:off x="5948280" y="2313000"/>
            <a:ext cx="0" cy="209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919840" y="231300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V="1">
            <a:off x="6586560" y="2093400"/>
            <a:ext cx="0" cy="209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6558120" y="209376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V="1">
            <a:off x="7215120" y="1874880"/>
            <a:ext cx="0" cy="209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7186680" y="187488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157480" y="2608200"/>
            <a:ext cx="5076720" cy="2228760"/>
          </a:xfrm>
          <a:custGeom>
            <a:avLst/>
            <a:gdLst/>
            <a:ahLst/>
            <a:rect l="l" t="t" r="r" b="b"/>
            <a:pathLst>
              <a:path w="533" h="234">
                <a:moveTo>
                  <a:pt x="0" y="234"/>
                </a:moveTo>
                <a:lnTo>
                  <a:pt x="67" y="184"/>
                </a:lnTo>
                <a:lnTo>
                  <a:pt x="133" y="137"/>
                </a:lnTo>
                <a:lnTo>
                  <a:pt x="200" y="90"/>
                </a:lnTo>
                <a:lnTo>
                  <a:pt x="266" y="46"/>
                </a:lnTo>
                <a:lnTo>
                  <a:pt x="333" y="22"/>
                </a:lnTo>
                <a:lnTo>
                  <a:pt x="400" y="4"/>
                </a:lnTo>
                <a:lnTo>
                  <a:pt x="466" y="14"/>
                </a:lnTo>
                <a:lnTo>
                  <a:pt x="533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2157480" y="4798800"/>
            <a:ext cx="0" cy="37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000" bIns="-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128680" y="4799160"/>
            <a:ext cx="66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2795760" y="4312800"/>
            <a:ext cx="0" cy="47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766960" y="431316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V="1">
            <a:off x="3424320" y="383688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395520" y="3836880"/>
            <a:ext cx="66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flipV="1">
            <a:off x="4062240" y="3370320"/>
            <a:ext cx="0" cy="95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4033800" y="33703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V="1">
            <a:off x="4691160" y="2941200"/>
            <a:ext cx="0" cy="104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662360" y="2941560"/>
            <a:ext cx="66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5329080" y="2722680"/>
            <a:ext cx="0" cy="95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5300640" y="272268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flipV="1">
            <a:off x="5967360" y="2484360"/>
            <a:ext cx="0" cy="162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938920" y="248436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flipV="1">
            <a:off x="6595920" y="2455920"/>
            <a:ext cx="0" cy="285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6567480" y="24559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flipV="1">
            <a:off x="7234200" y="2313000"/>
            <a:ext cx="0" cy="295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7205760" y="231300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2166840" y="2751120"/>
            <a:ext cx="5077080" cy="2085840"/>
          </a:xfrm>
          <a:custGeom>
            <a:avLst/>
            <a:gdLst/>
            <a:ahLst/>
            <a:rect l="l" t="t" r="r" b="b"/>
            <a:pathLst>
              <a:path w="533" h="219">
                <a:moveTo>
                  <a:pt x="0" y="219"/>
                </a:moveTo>
                <a:lnTo>
                  <a:pt x="67" y="169"/>
                </a:lnTo>
                <a:lnTo>
                  <a:pt x="134" y="120"/>
                </a:lnTo>
                <a:lnTo>
                  <a:pt x="200" y="73"/>
                </a:lnTo>
                <a:lnTo>
                  <a:pt x="267" y="34"/>
                </a:lnTo>
                <a:lnTo>
                  <a:pt x="333" y="9"/>
                </a:lnTo>
                <a:lnTo>
                  <a:pt x="400" y="2"/>
                </a:lnTo>
                <a:lnTo>
                  <a:pt x="467" y="13"/>
                </a:lnTo>
                <a:lnTo>
                  <a:pt x="533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flipV="1">
            <a:off x="2166840" y="4789440"/>
            <a:ext cx="0" cy="47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138400" y="478944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flipV="1">
            <a:off x="2805120" y="428472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776680" y="42847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flipV="1">
            <a:off x="3443400" y="3808440"/>
            <a:ext cx="0" cy="85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414600" y="3808440"/>
            <a:ext cx="66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flipV="1">
            <a:off x="4071960" y="337032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4043520" y="33703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flipV="1">
            <a:off x="4710240" y="2960640"/>
            <a:ext cx="0" cy="114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4681440" y="296064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flipV="1">
            <a:off x="5338800" y="2722320"/>
            <a:ext cx="0" cy="114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5310360" y="272268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 flipV="1">
            <a:off x="5977080" y="2531880"/>
            <a:ext cx="0" cy="237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5948280" y="253224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 flipV="1">
            <a:off x="6615000" y="2445840"/>
            <a:ext cx="0" cy="428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586560" y="244620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 flipV="1">
            <a:off x="7243920" y="2312640"/>
            <a:ext cx="0" cy="438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7215120" y="231300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185920" y="2532240"/>
            <a:ext cx="5076720" cy="2304720"/>
          </a:xfrm>
          <a:custGeom>
            <a:avLst/>
            <a:gdLst/>
            <a:ahLst/>
            <a:rect l="l" t="t" r="r" b="b"/>
            <a:pathLst>
              <a:path w="533" h="242">
                <a:moveTo>
                  <a:pt x="0" y="242"/>
                </a:moveTo>
                <a:lnTo>
                  <a:pt x="66" y="193"/>
                </a:lnTo>
                <a:lnTo>
                  <a:pt x="133" y="144"/>
                </a:lnTo>
                <a:lnTo>
                  <a:pt x="200" y="97"/>
                </a:lnTo>
                <a:lnTo>
                  <a:pt x="266" y="55"/>
                </a:lnTo>
                <a:lnTo>
                  <a:pt x="333" y="33"/>
                </a:lnTo>
                <a:lnTo>
                  <a:pt x="400" y="16"/>
                </a:lnTo>
                <a:lnTo>
                  <a:pt x="466" y="16"/>
                </a:lnTo>
                <a:lnTo>
                  <a:pt x="533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flipV="1">
            <a:off x="2185920" y="4789440"/>
            <a:ext cx="0" cy="47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2157480" y="478944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 flipV="1">
            <a:off x="2814480" y="429408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786040" y="429408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 flipV="1">
            <a:off x="3452760" y="3817440"/>
            <a:ext cx="0" cy="86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424320" y="381780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 flipV="1">
            <a:off x="4091040" y="3350880"/>
            <a:ext cx="0" cy="104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4062240" y="3351240"/>
            <a:ext cx="66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flipV="1">
            <a:off x="4719600" y="2941560"/>
            <a:ext cx="0" cy="114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4691160" y="294156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flipV="1">
            <a:off x="5357880" y="2732040"/>
            <a:ext cx="0" cy="114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5329080" y="2732040"/>
            <a:ext cx="66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flipV="1">
            <a:off x="5996160" y="253188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5967360" y="253224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flipV="1">
            <a:off x="6624720" y="2389320"/>
            <a:ext cx="0" cy="295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6595920" y="2389320"/>
            <a:ext cx="66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flipV="1">
            <a:off x="7262640" y="2198160"/>
            <a:ext cx="0" cy="333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7234200" y="21985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2195640" y="2674800"/>
            <a:ext cx="5076720" cy="2162160"/>
          </a:xfrm>
          <a:custGeom>
            <a:avLst/>
            <a:gdLst/>
            <a:ahLst/>
            <a:rect l="l" t="t" r="r" b="b"/>
            <a:pathLst>
              <a:path w="533" h="227">
                <a:moveTo>
                  <a:pt x="0" y="227"/>
                </a:moveTo>
                <a:lnTo>
                  <a:pt x="67" y="179"/>
                </a:lnTo>
                <a:lnTo>
                  <a:pt x="133" y="131"/>
                </a:lnTo>
                <a:lnTo>
                  <a:pt x="200" y="82"/>
                </a:lnTo>
                <a:lnTo>
                  <a:pt x="267" y="39"/>
                </a:lnTo>
                <a:lnTo>
                  <a:pt x="333" y="16"/>
                </a:lnTo>
                <a:lnTo>
                  <a:pt x="400" y="0"/>
                </a:lnTo>
                <a:lnTo>
                  <a:pt x="467" y="13"/>
                </a:lnTo>
                <a:lnTo>
                  <a:pt x="533" y="1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flipV="1">
            <a:off x="2195640" y="4789440"/>
            <a:ext cx="0" cy="47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2166840" y="478944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flipV="1">
            <a:off x="2833560" y="4322880"/>
            <a:ext cx="0" cy="56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2805120" y="432288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flipV="1">
            <a:off x="3462480" y="3827520"/>
            <a:ext cx="0" cy="95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3433680" y="38275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 flipV="1">
            <a:off x="4100400" y="3341520"/>
            <a:ext cx="0" cy="114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4071960" y="33415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flipV="1">
            <a:off x="4738680" y="2931840"/>
            <a:ext cx="0" cy="114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4710240" y="293220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flipV="1">
            <a:off x="5367240" y="2693520"/>
            <a:ext cx="0" cy="133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5338800" y="269388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flipV="1">
            <a:off x="6005520" y="2455920"/>
            <a:ext cx="0" cy="218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5977080" y="24559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flipV="1">
            <a:off x="6643800" y="2379600"/>
            <a:ext cx="0" cy="419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6615000" y="2379600"/>
            <a:ext cx="66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7272360" y="222732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7243920" y="22273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214720" y="2579760"/>
            <a:ext cx="5076720" cy="2257200"/>
          </a:xfrm>
          <a:custGeom>
            <a:avLst/>
            <a:gdLst/>
            <a:ahLst/>
            <a:rect l="l" t="t" r="r" b="b"/>
            <a:pathLst>
              <a:path w="533" h="237">
                <a:moveTo>
                  <a:pt x="0" y="237"/>
                </a:moveTo>
                <a:lnTo>
                  <a:pt x="66" y="186"/>
                </a:lnTo>
                <a:lnTo>
                  <a:pt x="133" y="134"/>
                </a:lnTo>
                <a:lnTo>
                  <a:pt x="200" y="85"/>
                </a:lnTo>
                <a:lnTo>
                  <a:pt x="266" y="43"/>
                </a:lnTo>
                <a:lnTo>
                  <a:pt x="333" y="16"/>
                </a:lnTo>
                <a:lnTo>
                  <a:pt x="399" y="0"/>
                </a:lnTo>
                <a:lnTo>
                  <a:pt x="466" y="15"/>
                </a:lnTo>
                <a:lnTo>
                  <a:pt x="533" y="7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flipV="1">
            <a:off x="2214720" y="4789440"/>
            <a:ext cx="0" cy="47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2185920" y="478944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 flipV="1">
            <a:off x="2843280" y="427500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2814480" y="4275000"/>
            <a:ext cx="66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flipV="1">
            <a:off x="3481560" y="3760920"/>
            <a:ext cx="0" cy="95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3452760" y="37609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 flipV="1">
            <a:off x="4119480" y="3274920"/>
            <a:ext cx="0" cy="114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4091040" y="32749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 flipV="1">
            <a:off x="4748040" y="2865600"/>
            <a:ext cx="0" cy="123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4719600" y="286560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flipV="1">
            <a:off x="5386320" y="2608200"/>
            <a:ext cx="0" cy="123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5357880" y="260820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 flipV="1">
            <a:off x="6014880" y="2455920"/>
            <a:ext cx="0" cy="123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5986440" y="24559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flipV="1">
            <a:off x="6653160" y="2541240"/>
            <a:ext cx="0" cy="181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6624720" y="254160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flipV="1">
            <a:off x="7291440" y="2446200"/>
            <a:ext cx="0" cy="200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7262640" y="2446200"/>
            <a:ext cx="66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2224080" y="2017800"/>
            <a:ext cx="5076720" cy="2819160"/>
          </a:xfrm>
          <a:custGeom>
            <a:avLst/>
            <a:gdLst/>
            <a:ahLst/>
            <a:rect l="l" t="t" r="r" b="b"/>
            <a:pathLst>
              <a:path w="533" h="296">
                <a:moveTo>
                  <a:pt x="0" y="296"/>
                </a:moveTo>
                <a:lnTo>
                  <a:pt x="67" y="247"/>
                </a:lnTo>
                <a:lnTo>
                  <a:pt x="133" y="197"/>
                </a:lnTo>
                <a:lnTo>
                  <a:pt x="200" y="149"/>
                </a:lnTo>
                <a:lnTo>
                  <a:pt x="267" y="106"/>
                </a:lnTo>
                <a:lnTo>
                  <a:pt x="333" y="74"/>
                </a:lnTo>
                <a:lnTo>
                  <a:pt x="400" y="47"/>
                </a:lnTo>
                <a:lnTo>
                  <a:pt x="466" y="22"/>
                </a:lnTo>
                <a:lnTo>
                  <a:pt x="533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 flipV="1">
            <a:off x="2224080" y="4789440"/>
            <a:ext cx="0" cy="47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2195640" y="478944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 flipV="1">
            <a:off x="2862360" y="4303440"/>
            <a:ext cx="0" cy="66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833560" y="4303800"/>
            <a:ext cx="66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flipV="1">
            <a:off x="3490920" y="381780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3462480" y="381780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 flipV="1">
            <a:off x="4129200" y="336060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4100400" y="3360600"/>
            <a:ext cx="66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 flipV="1">
            <a:off x="4767120" y="2960280"/>
            <a:ext cx="0" cy="66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4738680" y="296064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 flipV="1">
            <a:off x="5396040" y="264636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5367240" y="264636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 flipV="1">
            <a:off x="6033960" y="2360160"/>
            <a:ext cx="0" cy="104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6005520" y="23605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 flipV="1">
            <a:off x="6662880" y="2112840"/>
            <a:ext cx="0" cy="114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6634080" y="211284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 flipV="1">
            <a:off x="7300800" y="187452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7272360" y="187488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100240" y="4789440"/>
            <a:ext cx="85680" cy="856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2728800" y="4313160"/>
            <a:ext cx="85680" cy="856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3367080" y="3855960"/>
            <a:ext cx="85680" cy="856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3995640" y="3398760"/>
            <a:ext cx="85680" cy="856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4633920" y="3036960"/>
            <a:ext cx="85680" cy="856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5272200" y="2712960"/>
            <a:ext cx="85680" cy="856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5900760" y="2475000"/>
            <a:ext cx="85680" cy="856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6539040" y="2255760"/>
            <a:ext cx="85680" cy="856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7167600" y="2036880"/>
            <a:ext cx="85680" cy="8568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2109960" y="4789440"/>
            <a:ext cx="85680" cy="85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2747880" y="4313160"/>
            <a:ext cx="85680" cy="85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3376440" y="3865680"/>
            <a:ext cx="86040" cy="85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4014720" y="3417840"/>
            <a:ext cx="85680" cy="85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4643280" y="2998800"/>
            <a:ext cx="86040" cy="85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5281560" y="2770200"/>
            <a:ext cx="85680" cy="85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5919840" y="2598840"/>
            <a:ext cx="85680" cy="85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6548400" y="2693880"/>
            <a:ext cx="85680" cy="85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7186680" y="2560680"/>
            <a:ext cx="85680" cy="856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2119320" y="4789440"/>
            <a:ext cx="9540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2757600" y="4313160"/>
            <a:ext cx="9504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3395520" y="3846600"/>
            <a:ext cx="9540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4024440" y="3398760"/>
            <a:ext cx="9504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4662360" y="3027240"/>
            <a:ext cx="9540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5291280" y="2789280"/>
            <a:ext cx="9504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5929200" y="2722680"/>
            <a:ext cx="9540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6567480" y="2827440"/>
            <a:ext cx="9540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7196040" y="2703600"/>
            <a:ext cx="9540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2138400" y="4789440"/>
            <a:ext cx="9504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2766960" y="4322880"/>
            <a:ext cx="9540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3405240" y="3855960"/>
            <a:ext cx="9504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4043520" y="3408480"/>
            <a:ext cx="9504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4672080" y="3008160"/>
            <a:ext cx="9504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5310360" y="2798640"/>
            <a:ext cx="9504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5948280" y="2637000"/>
            <a:ext cx="9540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6576840" y="2637000"/>
            <a:ext cx="9540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7215120" y="2484360"/>
            <a:ext cx="9540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2147760" y="4789440"/>
            <a:ext cx="85680" cy="856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2786040" y="4332240"/>
            <a:ext cx="85680" cy="856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3414600" y="3875040"/>
            <a:ext cx="85680" cy="856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4052880" y="3408480"/>
            <a:ext cx="85680" cy="856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4691160" y="2998800"/>
            <a:ext cx="85680" cy="856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5319720" y="2779560"/>
            <a:ext cx="85680" cy="860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5958000" y="2627280"/>
            <a:ext cx="85680" cy="856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6595920" y="2751120"/>
            <a:ext cx="86040" cy="856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7224840" y="2637000"/>
            <a:ext cx="85680" cy="856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2166840" y="4789440"/>
            <a:ext cx="9540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2795760" y="4303800"/>
            <a:ext cx="9504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3433680" y="3808440"/>
            <a:ext cx="9540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4071960" y="3341520"/>
            <a:ext cx="9540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4700520" y="2941560"/>
            <a:ext cx="9540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5338800" y="2684520"/>
            <a:ext cx="9504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5967360" y="2532240"/>
            <a:ext cx="9540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6605640" y="2674800"/>
            <a:ext cx="9504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7243920" y="2598840"/>
            <a:ext cx="9504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60"/>
                </a:lnTo>
                <a:lnTo>
                  <a:pt x="0" y="6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2176560" y="4789440"/>
            <a:ext cx="9504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2814480" y="4322880"/>
            <a:ext cx="9540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3443400" y="3846600"/>
            <a:ext cx="9504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4081320" y="3389400"/>
            <a:ext cx="9540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4719600" y="2979720"/>
            <a:ext cx="9540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5348160" y="2674800"/>
            <a:ext cx="9540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5986440" y="2417760"/>
            <a:ext cx="9540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6615000" y="2179800"/>
            <a:ext cx="95400" cy="9504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7253280" y="1969920"/>
            <a:ext cx="95400" cy="9540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1669680" y="488484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1669680" y="437976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1669680" y="386568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1669680" y="33606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1669680" y="285588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1669680" y="235116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1669680" y="183672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1669680" y="13320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2108880" y="51134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2737440" y="51134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3327480" y="5113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3956040" y="5113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4594320" y="5113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5232600" y="5113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5861160" y="5113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6499440" y="5113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7128000" y="51134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4498560" y="5389560"/>
            <a:ext cx="366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ay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 rot="16200000">
            <a:off x="922680" y="3096360"/>
            <a:ext cx="1143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ody weight (g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1300320" y="1179360"/>
            <a:ext cx="6534000" cy="4505400"/>
          </a:xfrm>
          <a:prstGeom prst="rect">
            <a:avLst/>
          </a:pr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AutoShape 184"/>
          <p:cNvSpPr/>
          <p:nvPr/>
        </p:nvSpPr>
        <p:spPr>
          <a:xfrm>
            <a:off x="4498920" y="4479840"/>
            <a:ext cx="358920" cy="360360"/>
          </a:xfrm>
          <a:prstGeom prst="flowChartMerg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Rectangle 185"/>
          <p:cNvSpPr/>
          <p:nvPr/>
        </p:nvSpPr>
        <p:spPr>
          <a:xfrm>
            <a:off x="4635000" y="4162320"/>
            <a:ext cx="204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HGS創英角ｺﾞｼｯｸUB"/>
              </a:rPr>
              <a:t>0.05mg/site ADV injec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6346800" y="1827360"/>
            <a:ext cx="432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7012080" y="1603440"/>
            <a:ext cx="43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6588000" y="2179800"/>
            <a:ext cx="432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7227720" y="1946160"/>
            <a:ext cx="432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 Box 8"/>
          <p:cNvSpPr/>
          <p:nvPr/>
        </p:nvSpPr>
        <p:spPr>
          <a:xfrm>
            <a:off x="2495520" y="1473120"/>
            <a:ext cx="1644840" cy="1371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○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V-/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●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V+/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△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V+/ARA(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◇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V+/ARA(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□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V+/ARA(H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▲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V+/DH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◆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V+/CON+I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27T02:22:03Z</dcterms:created>
  <dc:creator>166373</dc:creator>
  <dc:description/>
  <dc:language>en-US</dc:language>
  <cp:lastModifiedBy>166373</cp:lastModifiedBy>
  <dcterms:modified xsi:type="dcterms:W3CDTF">2014-07-27T02:41:00Z</dcterms:modified>
  <cp:revision>5</cp:revision>
  <dc:subject/>
  <dc:title>スライド 1</dc:title>
</cp:coreProperties>
</file>